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5" r:id="rId4"/>
    <p:sldId id="257" r:id="rId5"/>
    <p:sldId id="258" r:id="rId6"/>
    <p:sldId id="256" r:id="rId7"/>
    <p:sldId id="327" r:id="rId8"/>
    <p:sldId id="328" r:id="rId9"/>
    <p:sldId id="329" r:id="rId10"/>
    <p:sldId id="260" r:id="rId11"/>
    <p:sldId id="261" r:id="rId12"/>
    <p:sldId id="259" r:id="rId13"/>
    <p:sldId id="262" r:id="rId14"/>
    <p:sldId id="266" r:id="rId15"/>
    <p:sldId id="267" r:id="rId16"/>
    <p:sldId id="326" r:id="rId1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66" d="100"/>
          <a:sy n="66" d="100"/>
        </p:scale>
        <p:origin x="51" y="80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637339-E368-4BF6-A9DA-5FFF799B2D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D679F5D-7F6B-43C1-A077-1B68F2F305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FF6D49-CF18-422B-88A3-72F792AF8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B82CA5-3EAA-43AD-A7D9-8EF9B6119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EC71C6-0507-486B-9A72-C5F9C2DAC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778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7B98D5-A1A9-428C-8396-6DEE033F59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836F68E-F4BB-417A-8494-1C02185DAB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D660B1-2F13-4462-965C-410A694FC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645C83-F727-4269-9823-55353F925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D4757B-4924-427D-B3DD-1EDCE20A5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17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EDD90BF-D5CA-4083-8F05-3A9902EEAD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94A143-6BCA-45F5-BDF7-6DCDFB172B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588EB2-15BD-4A19-AE71-54936E6C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32B4FA-E82E-499C-938E-228E64939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A0379C-D202-4156-AF89-BCECBF332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524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80D957-2FEE-4169-874E-4417FBF12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66ABDD-1B7B-46BA-AC98-7EE712A5A7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66668C-B785-4673-B1FF-0EE2A81A7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0D035E-1C7A-4884-B3E2-115217F06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7200E4-0F71-4096-AA0F-7B838AA41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18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DBD7C4-09D3-4B70-8543-695D52624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898782-AD1E-4096-A90D-52DFDAD08F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F32414-ECE6-41E7-B098-B53D752B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069674-DA4D-4694-94FB-88C40F291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3DC3DF-340D-49BB-B4DD-F631E5E82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777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D6D724-BC1F-4F5E-8443-12172DC4E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283E192-9A6C-47B4-B531-DC0A854161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83921F-C0D9-4CAE-A7AA-744CF5BCFC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CBCA8E-53CF-4A33-A09B-8834043FA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EE35F9-7B63-469C-BD39-6062C5F97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E4897A-B93C-4E11-881A-9007921B9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412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BDCAF1-31A5-4FF9-B0E4-64507FB12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57FEAE-0BAD-4A19-8EEA-EFC51E1F8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A12F2D3-30F0-4B51-99AC-63C26EB1C4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F74A9EC-616D-45E7-A810-FD3F75827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E58DEBD-89FD-4A8E-A828-AB5A1E2467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9ACD865-3B53-47BF-9AEC-7153604DD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28FF13A-5DD3-4E1A-B8FD-854E69A46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A39BE27-58B5-4C42-8898-8C31ED1B3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9505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69C002-43F2-4861-9BFF-70EEB312D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5C3850E-4EC5-49CF-B9AF-5010E115B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FD433DA-6A78-4C06-8931-C397AA94F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30EE694-600F-4EC7-B042-EE572D569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8099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468EA59-730F-4107-9D46-CBD0E82F4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2EE9B5B-2B32-4B8B-BA67-923371F2B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14EB848-3ED7-47C9-BDF2-78A77B215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148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9A9646-7FB5-4E2E-BAF6-467B8A959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02A6D8A-E4AD-4BDD-9CA6-4636A077B3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64E599E-FB0B-40AA-9EB4-6844A0DC05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F5A880E-3039-4180-B0DD-4542F35AE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9099E3-EB4A-49A2-A218-7E06ED3D7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1CD9A3-B373-4318-AD31-4544825B9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4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E05F55-6965-4C4B-8DE6-16D16321CE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324DA2D-2060-4E6B-B7C0-48F00B883C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AC20290-7782-4E2C-B50A-2BDF88068B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966438-A399-49F2-85E8-84D306773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017AA6-F95E-47A4-9D08-EA0D378E5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59A3B8-6E98-47DD-8603-89973A052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44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0B51FD4-C5F3-4025-BF3F-8201135BC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23DA574-841B-4C78-A341-CF5144022E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AD69F1-D4AA-4324-AB04-5C4FD7F0CC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C87C8-D95C-422B-913E-8D1973B51928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A86698-E36F-4FFB-8533-D2B12F75BD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A7A8DF-5D73-4F7A-A174-D53BD1166D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1610B-05C5-44FB-8DD9-18DB64F2F9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320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DBBC747-CCB2-4203-84C5-0A286D4EE9AA}"/>
              </a:ext>
            </a:extLst>
          </p:cNvPr>
          <p:cNvSpPr txBox="1"/>
          <p:nvPr/>
        </p:nvSpPr>
        <p:spPr>
          <a:xfrm>
            <a:off x="839189" y="663039"/>
            <a:ext cx="2528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 </a:t>
            </a:r>
            <a:r>
              <a:rPr lang="en-US" altLang="ja-JP" b="1" dirty="0"/>
              <a:t>RNase-P 1 </a:t>
            </a:r>
            <a:endParaRPr kumimoji="1" lang="ja-JP" altLang="en-US" b="1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0E39029F-5BA3-4CC8-8F7E-A46B5EA7E7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6" t="33882" r="1559" b="14113"/>
          <a:stretch/>
        </p:blipFill>
        <p:spPr>
          <a:xfrm>
            <a:off x="122711" y="1773381"/>
            <a:ext cx="11815949" cy="3566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35044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BF2BAE8-C686-458B-9054-1476735D23DA}"/>
              </a:ext>
            </a:extLst>
          </p:cNvPr>
          <p:cNvSpPr txBox="1"/>
          <p:nvPr/>
        </p:nvSpPr>
        <p:spPr>
          <a:xfrm>
            <a:off x="1223158" y="718457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 KIAA1549-BRAF 2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5437C3D-3274-42B9-B9BF-188FB168DC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2" t="9640" r="325" b="23117"/>
          <a:stretch/>
        </p:blipFill>
        <p:spPr>
          <a:xfrm>
            <a:off x="45522" y="1591294"/>
            <a:ext cx="12100956" cy="4611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72542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0A70CC-8545-4C01-A62C-0A4BE4E81A81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MVP KIAA1549-BRAF 2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24CDCB9-EC6E-4931-9368-2137E6BD90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7" t="9524" r="519" b="23001"/>
          <a:stretch/>
        </p:blipFill>
        <p:spPr>
          <a:xfrm>
            <a:off x="221673" y="1757989"/>
            <a:ext cx="11428021" cy="4381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13367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7BC6B4E9-6CB0-4C6C-BFAB-6651095C49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5" t="9697" r="617" b="20058"/>
          <a:stretch/>
        </p:blipFill>
        <p:spPr>
          <a:xfrm>
            <a:off x="73231" y="1773381"/>
            <a:ext cx="12045538" cy="481742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7A43AEB-C77E-451A-9C06-DAA6906C9203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/MVP KIAA1549-BRAF 2</a:t>
            </a:r>
            <a:endParaRPr kumimoji="1" lang="ja-JP" altLang="en-US" b="1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B1E0308-A123-48C9-80CE-34798D315DB9}"/>
              </a:ext>
            </a:extLst>
          </p:cNvPr>
          <p:cNvSpPr/>
          <p:nvPr/>
        </p:nvSpPr>
        <p:spPr>
          <a:xfrm>
            <a:off x="6068291" y="4670960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C171A6A-3C2F-466F-9B28-BFDAA527D37C}"/>
              </a:ext>
            </a:extLst>
          </p:cNvPr>
          <p:cNvSpPr/>
          <p:nvPr/>
        </p:nvSpPr>
        <p:spPr>
          <a:xfrm>
            <a:off x="6068291" y="5753593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2072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C9A42C-3F60-44BB-BD50-CFA29101C499}"/>
              </a:ext>
            </a:extLst>
          </p:cNvPr>
          <p:cNvSpPr txBox="1"/>
          <p:nvPr/>
        </p:nvSpPr>
        <p:spPr>
          <a:xfrm>
            <a:off x="1223158" y="718457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 KIAA1549-BRAF 3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3360DA7-A47F-4B14-929F-E38AB6934F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2" t="9581" r="421" b="23059"/>
          <a:stretch/>
        </p:blipFill>
        <p:spPr>
          <a:xfrm>
            <a:off x="91045" y="1622960"/>
            <a:ext cx="12073246" cy="46195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42408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0626EF0-3C81-4D20-891C-4FCE4E01535F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MVP KIAA1549-BRAF 3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CF58B8B-0F60-4BA7-8B2B-C3724EE01E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9" t="9697" r="422" b="23001"/>
          <a:stretch/>
        </p:blipFill>
        <p:spPr>
          <a:xfrm>
            <a:off x="57397" y="1630878"/>
            <a:ext cx="12077206" cy="4615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14764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F567D62A-00D3-48D4-A48C-F6FDE71E51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5" t="9581" r="682" b="20115"/>
          <a:stretch/>
        </p:blipFill>
        <p:spPr>
          <a:xfrm>
            <a:off x="69272" y="1587334"/>
            <a:ext cx="12053455" cy="482138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7ABE41-2C10-42E7-9B9E-4D95B0BABB14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6 tumor/MVP KIAA1549-BRAF 3</a:t>
            </a:r>
            <a:endParaRPr kumimoji="1" lang="ja-JP" altLang="en-US" b="1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2DFE3D6-7AE6-424E-8A27-599E4D1A5B0B}"/>
              </a:ext>
            </a:extLst>
          </p:cNvPr>
          <p:cNvSpPr/>
          <p:nvPr/>
        </p:nvSpPr>
        <p:spPr>
          <a:xfrm>
            <a:off x="6096000" y="5652654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A3387F7-D31E-4F57-97A2-56F9F1ECE755}"/>
              </a:ext>
            </a:extLst>
          </p:cNvPr>
          <p:cNvSpPr/>
          <p:nvPr/>
        </p:nvSpPr>
        <p:spPr>
          <a:xfrm>
            <a:off x="6096000" y="4542310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9251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0BCA27FC-618D-49F8-B36F-521C3506E6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025847"/>
              </p:ext>
            </p:extLst>
          </p:nvPr>
        </p:nvGraphicFramePr>
        <p:xfrm>
          <a:off x="323352" y="2591030"/>
          <a:ext cx="11545296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4216">
                  <a:extLst>
                    <a:ext uri="{9D8B030D-6E8A-4147-A177-3AD203B41FA5}">
                      <a16:colId xmlns:a16="http://schemas.microsoft.com/office/drawing/2014/main" val="922732477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3094276893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2507284571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1961806223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465009027"/>
                    </a:ext>
                  </a:extLst>
                </a:gridCol>
                <a:gridCol w="1924216">
                  <a:extLst>
                    <a:ext uri="{9D8B030D-6E8A-4147-A177-3AD203B41FA5}">
                      <a16:colId xmlns:a16="http://schemas.microsoft.com/office/drawing/2014/main" val="3466714734"/>
                    </a:ext>
                  </a:extLst>
                </a:gridCol>
              </a:tblGrid>
              <a:tr h="370840"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Tumor</a:t>
                      </a:r>
                      <a:endParaRPr kumimoji="1" lang="ja-JP" altLang="en-US" dirty="0"/>
                    </a:p>
                  </a:txBody>
                  <a:tcPr>
                    <a:solidFill>
                      <a:srgbClr val="00B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>
                    <a:solidFill>
                      <a:srgbClr val="00B0F0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MVP</a:t>
                      </a:r>
                      <a:endParaRPr kumimoji="1" lang="ja-JP" altLang="en-US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80433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="1" dirty="0"/>
                        <a:t>RNase-P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/>
                        <a:t>KIAA-BRAF</a:t>
                      </a:r>
                      <a:r>
                        <a:rPr kumimoji="1" lang="en-US" altLang="ja-JP" sz="1600" b="1" dirty="0"/>
                        <a:t>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/>
                        <a:t>KIAA-BRAF/RNase</a:t>
                      </a:r>
                      <a:endParaRPr kumimoji="1" lang="ja-JP" alt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/>
                        <a:t>RNase-P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/>
                        <a:t>KIAA-BRAF</a:t>
                      </a:r>
                      <a:r>
                        <a:rPr kumimoji="1" lang="en-US" altLang="ja-JP" sz="1600" b="1" dirty="0"/>
                        <a:t> </a:t>
                      </a:r>
                      <a:r>
                        <a:rPr kumimoji="1" lang="en-US" altLang="ja-JP" sz="1000" b="1" dirty="0"/>
                        <a:t>(copies/</a:t>
                      </a:r>
                      <a:r>
                        <a:rPr kumimoji="1" lang="en-US" altLang="ja-JP" sz="1000" b="1" dirty="0" err="1"/>
                        <a:t>ul</a:t>
                      </a:r>
                      <a:r>
                        <a:rPr kumimoji="1" lang="en-US" altLang="ja-JP" sz="1000" b="1" dirty="0"/>
                        <a:t>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/>
                        <a:t>KIAA-BRAF/RNase</a:t>
                      </a:r>
                      <a:endParaRPr kumimoji="1" lang="ja-JP" alt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40235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735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82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124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47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42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285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7824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525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4.723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8.99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0.287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.020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3.750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06835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.14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13.6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2.188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/>
                        <a:t>7.623</a:t>
                      </a:r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5139638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7CFA541-89E2-40AC-8322-E752E4864300}"/>
              </a:ext>
            </a:extLst>
          </p:cNvPr>
          <p:cNvSpPr txBox="1"/>
          <p:nvPr/>
        </p:nvSpPr>
        <p:spPr>
          <a:xfrm>
            <a:off x="1492332" y="1490354"/>
            <a:ext cx="89514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Expression of KIAA1549-BRAF and RNase-P in S6 samples</a:t>
            </a:r>
            <a:endParaRPr kumimoji="1" lang="ja-JP" altLang="en-US" sz="2400" b="1" dirty="0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EC544F2-1F6F-459E-A7FE-8B49F1E9542C}"/>
              </a:ext>
            </a:extLst>
          </p:cNvPr>
          <p:cNvCxnSpPr/>
          <p:nvPr/>
        </p:nvCxnSpPr>
        <p:spPr>
          <a:xfrm>
            <a:off x="323352" y="3701143"/>
            <a:ext cx="115452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4220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DB52E63-C6C6-4869-B851-4E8EEA870AE1}"/>
              </a:ext>
            </a:extLst>
          </p:cNvPr>
          <p:cNvSpPr txBox="1"/>
          <p:nvPr/>
        </p:nvSpPr>
        <p:spPr>
          <a:xfrm>
            <a:off x="839189" y="663039"/>
            <a:ext cx="2400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MVP </a:t>
            </a:r>
            <a:r>
              <a:rPr lang="en-US" altLang="ja-JP" b="1" dirty="0"/>
              <a:t>RNase-P 1 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350E6D6-FE92-41F8-AE8F-BFC2CF41B57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6" t="33939" r="1559" b="14113"/>
          <a:stretch/>
        </p:blipFill>
        <p:spPr>
          <a:xfrm>
            <a:off x="126669" y="1735169"/>
            <a:ext cx="11815949" cy="3562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66873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176415DD-048B-4428-AC1E-8DF97330F0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2" t="9668" r="1038" b="20808"/>
          <a:stretch/>
        </p:blipFill>
        <p:spPr>
          <a:xfrm>
            <a:off x="96982" y="1256805"/>
            <a:ext cx="11998036" cy="476794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2CA844B-C806-42BB-B6D3-70D73AA84C83}"/>
              </a:ext>
            </a:extLst>
          </p:cNvPr>
          <p:cNvSpPr txBox="1"/>
          <p:nvPr/>
        </p:nvSpPr>
        <p:spPr>
          <a:xfrm>
            <a:off x="839189" y="663039"/>
            <a:ext cx="3182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/MVP </a:t>
            </a:r>
            <a:r>
              <a:rPr lang="en-US" altLang="ja-JP" b="1" dirty="0"/>
              <a:t>RNase-P 1 </a:t>
            </a:r>
            <a:endParaRPr kumimoji="1" lang="ja-JP" altLang="en-US" b="1" dirty="0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F2F2A25-779F-4267-87CC-8529E87F1A43}"/>
              </a:ext>
            </a:extLst>
          </p:cNvPr>
          <p:cNvSpPr/>
          <p:nvPr/>
        </p:nvSpPr>
        <p:spPr>
          <a:xfrm>
            <a:off x="6096000" y="5023262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904FA30-4D46-418B-8F25-01FB2B106051}"/>
              </a:ext>
            </a:extLst>
          </p:cNvPr>
          <p:cNvSpPr/>
          <p:nvPr/>
        </p:nvSpPr>
        <p:spPr>
          <a:xfrm>
            <a:off x="6096000" y="5567547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8853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7CC91E1-A4D5-4170-839B-5283B6B14344}"/>
              </a:ext>
            </a:extLst>
          </p:cNvPr>
          <p:cNvSpPr txBox="1"/>
          <p:nvPr/>
        </p:nvSpPr>
        <p:spPr>
          <a:xfrm>
            <a:off x="839189" y="476992"/>
            <a:ext cx="3284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 </a:t>
            </a:r>
            <a:r>
              <a:rPr lang="en-US" altLang="ja-JP" b="1" dirty="0"/>
              <a:t>KIAA1549-BRAF </a:t>
            </a:r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56B772A3-E590-4A04-9332-A7CA6D3B2C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61" t="33824" r="1559" b="13882"/>
          <a:stretch/>
        </p:blipFill>
        <p:spPr>
          <a:xfrm>
            <a:off x="134587" y="1899011"/>
            <a:ext cx="11823865" cy="35863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92300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98DF79E-AE12-4ABF-81F9-0763050B5605}"/>
              </a:ext>
            </a:extLst>
          </p:cNvPr>
          <p:cNvSpPr txBox="1"/>
          <p:nvPr/>
        </p:nvSpPr>
        <p:spPr>
          <a:xfrm>
            <a:off x="1223158" y="718457"/>
            <a:ext cx="3156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MVP </a:t>
            </a:r>
            <a:r>
              <a:rPr lang="en-US" altLang="ja-JP" b="1" dirty="0"/>
              <a:t>KIAA1549-BRAF </a:t>
            </a:r>
            <a:r>
              <a:rPr kumimoji="1" lang="en-US" altLang="ja-JP" b="1" dirty="0"/>
              <a:t>1</a:t>
            </a:r>
            <a:endParaRPr kumimoji="1" lang="ja-JP" altLang="en-US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C0958D6-5DF9-4F25-94E2-CE2E48F6F2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59" t="34055" r="1493" b="13593"/>
          <a:stretch/>
        </p:blipFill>
        <p:spPr>
          <a:xfrm>
            <a:off x="186046" y="1733797"/>
            <a:ext cx="11819908" cy="3590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8718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E3B2E55-3C3B-4EF8-9C33-EBA16497C0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1" t="9524" r="422" b="20405"/>
          <a:stretch/>
        </p:blipFill>
        <p:spPr>
          <a:xfrm>
            <a:off x="178129" y="1472539"/>
            <a:ext cx="12057414" cy="4805549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B62BF6A-A24D-4F04-BDE9-6D5135275125}"/>
              </a:ext>
            </a:extLst>
          </p:cNvPr>
          <p:cNvSpPr/>
          <p:nvPr/>
        </p:nvSpPr>
        <p:spPr>
          <a:xfrm>
            <a:off x="6167252" y="4500748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16D09CF-988D-4947-B4A5-1949F47C84BB}"/>
              </a:ext>
            </a:extLst>
          </p:cNvPr>
          <p:cNvSpPr/>
          <p:nvPr/>
        </p:nvSpPr>
        <p:spPr>
          <a:xfrm>
            <a:off x="6167252" y="5033158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E898DFC-3AAE-4BED-9814-BF4156D545D8}"/>
              </a:ext>
            </a:extLst>
          </p:cNvPr>
          <p:cNvSpPr txBox="1"/>
          <p:nvPr/>
        </p:nvSpPr>
        <p:spPr>
          <a:xfrm>
            <a:off x="1223158" y="718457"/>
            <a:ext cx="3938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/MVP KIAA1549-BRAF 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691329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02F6A638-874B-477D-82D6-0D0ECFC614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1" t="9581" r="324" b="22597"/>
          <a:stretch/>
        </p:blipFill>
        <p:spPr>
          <a:xfrm>
            <a:off x="51459" y="1591293"/>
            <a:ext cx="12089081" cy="465117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C6980CE-C33A-4816-B104-D80F3149EE08}"/>
              </a:ext>
            </a:extLst>
          </p:cNvPr>
          <p:cNvSpPr txBox="1"/>
          <p:nvPr/>
        </p:nvSpPr>
        <p:spPr>
          <a:xfrm>
            <a:off x="839189" y="663039"/>
            <a:ext cx="2528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 </a:t>
            </a:r>
            <a:r>
              <a:rPr lang="en-US" altLang="ja-JP" b="1" dirty="0"/>
              <a:t>RNase-P 2 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7968202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E3D5806-2E01-4BFF-934B-B80EA5ADBB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6" t="9524" r="293" b="23117"/>
          <a:stretch/>
        </p:blipFill>
        <p:spPr>
          <a:xfrm>
            <a:off x="39584" y="1567543"/>
            <a:ext cx="12112832" cy="461950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88C5779-D47E-4FF7-A41E-5630FDA0241B}"/>
              </a:ext>
            </a:extLst>
          </p:cNvPr>
          <p:cNvSpPr txBox="1"/>
          <p:nvPr/>
        </p:nvSpPr>
        <p:spPr>
          <a:xfrm>
            <a:off x="839189" y="663039"/>
            <a:ext cx="2400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MVP </a:t>
            </a:r>
            <a:r>
              <a:rPr lang="en-US" altLang="ja-JP" b="1" dirty="0"/>
              <a:t>RNase-P 2 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9812799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7424416-F3CE-4F86-8630-767B1F79FE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9" t="9581" r="390" b="19942"/>
          <a:stretch/>
        </p:blipFill>
        <p:spPr>
          <a:xfrm>
            <a:off x="39584" y="1555668"/>
            <a:ext cx="12112831" cy="4833258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40C7176C-3C40-472A-A89F-6CA885EC2469}"/>
              </a:ext>
            </a:extLst>
          </p:cNvPr>
          <p:cNvSpPr/>
          <p:nvPr/>
        </p:nvSpPr>
        <p:spPr>
          <a:xfrm>
            <a:off x="6095999" y="4520540"/>
            <a:ext cx="1417122" cy="22958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D60AB19-C926-4D30-B4B0-4A3D4851BE14}"/>
              </a:ext>
            </a:extLst>
          </p:cNvPr>
          <p:cNvSpPr/>
          <p:nvPr/>
        </p:nvSpPr>
        <p:spPr>
          <a:xfrm>
            <a:off x="6095999" y="5615048"/>
            <a:ext cx="1417122" cy="22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E06A970-FE33-4117-803A-AAE7D14593E7}"/>
              </a:ext>
            </a:extLst>
          </p:cNvPr>
          <p:cNvSpPr txBox="1"/>
          <p:nvPr/>
        </p:nvSpPr>
        <p:spPr>
          <a:xfrm>
            <a:off x="839189" y="663039"/>
            <a:ext cx="31822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tumor/MVP </a:t>
            </a:r>
            <a:r>
              <a:rPr lang="en-US" altLang="ja-JP" b="1" dirty="0"/>
              <a:t>RNase-P 2 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171608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126</Words>
  <Application>Microsoft Office PowerPoint</Application>
  <PresentationFormat>ワイド画面</PresentationFormat>
  <Paragraphs>40</Paragraphs>
  <Slides>1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6</vt:i4>
      </vt:variant>
    </vt:vector>
  </HeadingPairs>
  <TitlesOfParts>
    <vt:vector size="20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ji</dc:creator>
  <cp:lastModifiedBy>Shinji</cp:lastModifiedBy>
  <cp:revision>13</cp:revision>
  <dcterms:created xsi:type="dcterms:W3CDTF">2019-04-16T03:17:59Z</dcterms:created>
  <dcterms:modified xsi:type="dcterms:W3CDTF">2019-04-16T06:37:07Z</dcterms:modified>
</cp:coreProperties>
</file>